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30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DFF5C-3F73-4956-AB41-7F55F14F7338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47738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953598-F347-49FF-8870-2BA1BB1801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183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342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32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079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4117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6713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1875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2270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0722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3030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713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828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7099E-E733-47B7-8CE7-E2CB725ACF20}" type="datetimeFigureOut">
              <a:rPr lang="de-DE" smtClean="0"/>
              <a:t>13.04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3012C-4601-44D4-A6F1-A7218B4EDC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2342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uppieren 39"/>
          <p:cNvGrpSpPr/>
          <p:nvPr/>
        </p:nvGrpSpPr>
        <p:grpSpPr>
          <a:xfrm>
            <a:off x="1403648" y="1844824"/>
            <a:ext cx="4856672" cy="2632101"/>
            <a:chOff x="3898727" y="1411597"/>
            <a:chExt cx="4856672" cy="2632101"/>
          </a:xfrm>
        </p:grpSpPr>
        <p:sp>
          <p:nvSpPr>
            <p:cNvPr id="5" name="Rechteck 4"/>
            <p:cNvSpPr/>
            <p:nvPr/>
          </p:nvSpPr>
          <p:spPr>
            <a:xfrm>
              <a:off x="4716016" y="1411597"/>
              <a:ext cx="3150688" cy="201717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48" t="3131" r="31073" b="16126"/>
            <a:stretch/>
          </p:blipFill>
          <p:spPr>
            <a:xfrm>
              <a:off x="6426544" y="1417475"/>
              <a:ext cx="1440160" cy="2016224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6112568" y="1662666"/>
              <a:ext cx="428991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/>
                <a:t>kD</a:t>
              </a:r>
              <a:endParaRPr lang="de-DE" sz="1200" dirty="0"/>
            </a:p>
            <a:p>
              <a:endParaRPr lang="de-DE" sz="1200" dirty="0"/>
            </a:p>
            <a:p>
              <a:r>
                <a:rPr lang="de-DE" sz="1200" dirty="0"/>
                <a:t>80</a:t>
              </a:r>
            </a:p>
            <a:p>
              <a:r>
                <a:rPr lang="de-DE" sz="1200" dirty="0"/>
                <a:t>60</a:t>
              </a:r>
            </a:p>
            <a:p>
              <a:r>
                <a:rPr lang="de-DE" sz="1200" dirty="0"/>
                <a:t>50</a:t>
              </a:r>
            </a:p>
            <a:p>
              <a:r>
                <a:rPr lang="de-DE" sz="1200" dirty="0"/>
                <a:t>40</a:t>
              </a:r>
            </a:p>
          </p:txBody>
        </p:sp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32000" contrast="2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09" t="4671" r="6449" b="16354"/>
            <a:stretch/>
          </p:blipFill>
          <p:spPr>
            <a:xfrm>
              <a:off x="4716016" y="1411597"/>
              <a:ext cx="1462031" cy="2017174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3898727" y="3274257"/>
              <a:ext cx="485667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de-DE" sz="1100" dirty="0"/>
            </a:p>
            <a:p>
              <a:pPr>
                <a:tabLst>
                  <a:tab pos="1343025" algn="l"/>
                  <a:tab pos="1701800" algn="l"/>
                  <a:tab pos="3052763" algn="l"/>
                </a:tabLst>
              </a:pPr>
              <a:r>
                <a:rPr lang="de-DE" sz="1100" dirty="0" err="1"/>
                <a:t>control</a:t>
              </a:r>
              <a:r>
                <a:rPr lang="de-DE" sz="1100" dirty="0"/>
                <a:t> </a:t>
              </a:r>
              <a:r>
                <a:rPr lang="de-DE" sz="1100" dirty="0" err="1"/>
                <a:t>No</a:t>
              </a:r>
              <a:r>
                <a:rPr lang="de-DE" sz="1100" dirty="0"/>
                <a:t>        1              2             3                      1            2            3</a:t>
              </a:r>
            </a:p>
            <a:p>
              <a:pPr defTabSz="715963"/>
              <a:r>
                <a:rPr lang="de-DE" sz="1100" dirty="0" err="1"/>
                <a:t>gliadins</a:t>
              </a:r>
              <a:r>
                <a:rPr lang="de-DE" sz="1100" dirty="0"/>
                <a:t>	   </a:t>
              </a:r>
              <a:r>
                <a:rPr lang="de-DE" sz="1100" b="1" dirty="0"/>
                <a:t>-    +       -     +       -</a:t>
              </a:r>
              <a:r>
                <a:rPr lang="de-DE" sz="1100" dirty="0"/>
                <a:t>    </a:t>
              </a:r>
              <a:r>
                <a:rPr lang="de-DE" sz="1100" b="1" dirty="0"/>
                <a:t> +               -     +     -     +      -</a:t>
              </a:r>
              <a:r>
                <a:rPr lang="de-DE" sz="1100" dirty="0"/>
                <a:t>    </a:t>
              </a:r>
              <a:r>
                <a:rPr lang="de-DE" sz="1100" b="1" dirty="0"/>
                <a:t> +</a:t>
              </a:r>
            </a:p>
            <a:p>
              <a:pPr defTabSz="715963"/>
              <a:endParaRPr lang="de-DE" sz="1100" b="1" dirty="0"/>
            </a:p>
          </p:txBody>
        </p:sp>
        <p:grpSp>
          <p:nvGrpSpPr>
            <p:cNvPr id="8" name="Gruppieren 7"/>
            <p:cNvGrpSpPr/>
            <p:nvPr/>
          </p:nvGrpSpPr>
          <p:grpSpPr>
            <a:xfrm>
              <a:off x="4750809" y="3355371"/>
              <a:ext cx="437569" cy="84206"/>
              <a:chOff x="2520462" y="5133836"/>
              <a:chExt cx="585048" cy="55994"/>
            </a:xfrm>
          </p:grpSpPr>
          <p:cxnSp>
            <p:nvCxnSpPr>
              <p:cNvPr id="9" name="Gerader Verbinder 8"/>
              <p:cNvCxnSpPr/>
              <p:nvPr/>
            </p:nvCxnSpPr>
            <p:spPr>
              <a:xfrm>
                <a:off x="2520539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" name="Gruppieren 9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11" name="Gerader Verbinder 10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Gerader Verbinder 11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" name="Gruppieren 12"/>
            <p:cNvGrpSpPr/>
            <p:nvPr/>
          </p:nvGrpSpPr>
          <p:grpSpPr>
            <a:xfrm>
              <a:off x="5224478" y="3355371"/>
              <a:ext cx="437568" cy="84206"/>
              <a:chOff x="2520462" y="5133836"/>
              <a:chExt cx="585047" cy="55994"/>
            </a:xfrm>
          </p:grpSpPr>
          <p:cxnSp>
            <p:nvCxnSpPr>
              <p:cNvPr id="14" name="Gerader Verbinder 13"/>
              <p:cNvCxnSpPr/>
              <p:nvPr/>
            </p:nvCxnSpPr>
            <p:spPr>
              <a:xfrm>
                <a:off x="2520538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" name="Gruppieren 14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16" name="Gerader Verbinder 15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Gerader Verbinder 16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" name="Gruppieren 17"/>
            <p:cNvGrpSpPr/>
            <p:nvPr/>
          </p:nvGrpSpPr>
          <p:grpSpPr>
            <a:xfrm>
              <a:off x="5690598" y="3355371"/>
              <a:ext cx="437568" cy="84206"/>
              <a:chOff x="2520462" y="5133836"/>
              <a:chExt cx="585047" cy="55994"/>
            </a:xfrm>
          </p:grpSpPr>
          <p:cxnSp>
            <p:nvCxnSpPr>
              <p:cNvPr id="19" name="Gerader Verbinder 18"/>
              <p:cNvCxnSpPr/>
              <p:nvPr/>
            </p:nvCxnSpPr>
            <p:spPr>
              <a:xfrm>
                <a:off x="2520538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0" name="Gruppieren 19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21" name="Gerader Verbinder 20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Gerader Verbinder 21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3" name="Gruppieren 22"/>
            <p:cNvGrpSpPr/>
            <p:nvPr/>
          </p:nvGrpSpPr>
          <p:grpSpPr>
            <a:xfrm>
              <a:off x="6440824" y="3355371"/>
              <a:ext cx="437568" cy="84206"/>
              <a:chOff x="2520462" y="5133836"/>
              <a:chExt cx="585047" cy="55994"/>
            </a:xfrm>
          </p:grpSpPr>
          <p:cxnSp>
            <p:nvCxnSpPr>
              <p:cNvPr id="24" name="Gerader Verbinder 23"/>
              <p:cNvCxnSpPr/>
              <p:nvPr/>
            </p:nvCxnSpPr>
            <p:spPr>
              <a:xfrm>
                <a:off x="2520538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" name="Gruppieren 24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26" name="Gerader Verbinder 25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Gerader Verbinder 26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" name="Gruppieren 27"/>
            <p:cNvGrpSpPr/>
            <p:nvPr/>
          </p:nvGrpSpPr>
          <p:grpSpPr>
            <a:xfrm>
              <a:off x="6911485" y="3355371"/>
              <a:ext cx="437568" cy="84206"/>
              <a:chOff x="2520462" y="5133836"/>
              <a:chExt cx="585047" cy="55994"/>
            </a:xfrm>
          </p:grpSpPr>
          <p:cxnSp>
            <p:nvCxnSpPr>
              <p:cNvPr id="29" name="Gerader Verbinder 28"/>
              <p:cNvCxnSpPr/>
              <p:nvPr/>
            </p:nvCxnSpPr>
            <p:spPr>
              <a:xfrm>
                <a:off x="2520538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0" name="Gruppieren 29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31" name="Gerader Verbinder 30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Gerader Verbinder 31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3" name="Gruppieren 32"/>
            <p:cNvGrpSpPr/>
            <p:nvPr/>
          </p:nvGrpSpPr>
          <p:grpSpPr>
            <a:xfrm>
              <a:off x="7374430" y="3355371"/>
              <a:ext cx="437568" cy="84206"/>
              <a:chOff x="2520462" y="5133836"/>
              <a:chExt cx="585047" cy="55994"/>
            </a:xfrm>
          </p:grpSpPr>
          <p:cxnSp>
            <p:nvCxnSpPr>
              <p:cNvPr id="34" name="Gerader Verbinder 33"/>
              <p:cNvCxnSpPr/>
              <p:nvPr/>
            </p:nvCxnSpPr>
            <p:spPr>
              <a:xfrm>
                <a:off x="2520538" y="5185281"/>
                <a:ext cx="58497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Gruppieren 34"/>
              <p:cNvGrpSpPr/>
              <p:nvPr/>
            </p:nvGrpSpPr>
            <p:grpSpPr>
              <a:xfrm>
                <a:off x="2520462" y="5133836"/>
                <a:ext cx="585047" cy="55994"/>
                <a:chOff x="2520462" y="5133836"/>
                <a:chExt cx="585047" cy="55994"/>
              </a:xfrm>
            </p:grpSpPr>
            <p:cxnSp>
              <p:nvCxnSpPr>
                <p:cNvPr id="36" name="Gerader Verbinder 35"/>
                <p:cNvCxnSpPr/>
                <p:nvPr/>
              </p:nvCxnSpPr>
              <p:spPr>
                <a:xfrm flipH="1">
                  <a:off x="3105039" y="5136107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Gerader Verbinder 36"/>
                <p:cNvCxnSpPr/>
                <p:nvPr/>
              </p:nvCxnSpPr>
              <p:spPr>
                <a:xfrm flipH="1">
                  <a:off x="2520462" y="5133836"/>
                  <a:ext cx="470" cy="53723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8" name="Textfeld 37"/>
            <p:cNvSpPr txBox="1"/>
            <p:nvPr/>
          </p:nvSpPr>
          <p:spPr>
            <a:xfrm>
              <a:off x="4716016" y="1454587"/>
              <a:ext cx="2880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6426544" y="1454587"/>
              <a:ext cx="2880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7" name="Rechteck 6"/>
          <p:cNvSpPr/>
          <p:nvPr/>
        </p:nvSpPr>
        <p:spPr>
          <a:xfrm>
            <a:off x="1187624" y="543518"/>
            <a:ext cx="560193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xample of a Western blot to demonstrate ß-actin as 40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rotein in PBMC cell lysate of three healthy controls before and after 24 hours stimulation with gliadins. a) Protein staining (fluorescence) of PBMC lysates separated on 4-12% TGX Stain-Free™ protein gel after transfer to nitrocellulose. b) Western blot for ß-actin.</a:t>
            </a:r>
            <a:endParaRPr lang="de-DE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768100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Bildschirmpräsentation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eterich, Walburga</dc:creator>
  <cp:lastModifiedBy>Dieterich, Walburga</cp:lastModifiedBy>
  <cp:revision>31</cp:revision>
  <cp:lastPrinted>2019-02-07T08:19:19Z</cp:lastPrinted>
  <dcterms:created xsi:type="dcterms:W3CDTF">2019-01-14T15:11:06Z</dcterms:created>
  <dcterms:modified xsi:type="dcterms:W3CDTF">2022-04-13T11:30:59Z</dcterms:modified>
</cp:coreProperties>
</file>